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345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61000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7395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45500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492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41160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158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9550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6042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027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925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7DDAC6-CEAF-49DB-BCCC-323E8972320F}" type="datetimeFigureOut">
              <a:rPr lang="en-US" smtClean="0"/>
              <a:t>3/2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F24D83-6083-424B-99D5-52D1A6ECE1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044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9089242"/>
              </p:ext>
            </p:extLst>
          </p:nvPr>
        </p:nvGraphicFramePr>
        <p:xfrm>
          <a:off x="3694952" y="1030441"/>
          <a:ext cx="4505434" cy="37896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058924">
                  <a:extLst>
                    <a:ext uri="{9D8B030D-6E8A-4147-A177-3AD203B41FA5}">
                      <a16:colId xmlns:a16="http://schemas.microsoft.com/office/drawing/2014/main" val="665413642"/>
                    </a:ext>
                  </a:extLst>
                </a:gridCol>
                <a:gridCol w="2446510">
                  <a:extLst>
                    <a:ext uri="{9D8B030D-6E8A-4147-A177-3AD203B41FA5}">
                      <a16:colId xmlns:a16="http://schemas.microsoft.com/office/drawing/2014/main" val="4153058449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Z GWAS </a:t>
                      </a:r>
                    </a:p>
                    <a:p>
                      <a:pPr algn="ctr"/>
                      <a:r>
                        <a:rPr lang="en-US" sz="2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</a:t>
                      </a:r>
                      <a:r>
                        <a:rPr lang="en-US" sz="24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value*</a:t>
                      </a:r>
                      <a:endParaRPr lang="en-US" sz="2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b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106753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1" i="1" cap="all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NKSR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06e-12</a:t>
                      </a:r>
                      <a:endParaRPr lang="en-US" sz="16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71789479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1" i="1" cap="all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in2a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e-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11452254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1" i="1" cap="all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6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178e-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63153431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1" i="1" cap="all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ch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01e-1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93707471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1" i="1" cap="all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3hdm2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5e-1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86973505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1" i="1" cap="all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ms1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88e-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35017964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1" i="1" cap="all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bc1d5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642e-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6739601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sz="1600" b="1" i="1" cap="all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F4</a:t>
                      </a:r>
                    </a:p>
                  </a:txBody>
                  <a:tcPr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37e-1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214695576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3698752" y="4876223"/>
            <a:ext cx="44978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*from Supplementary Table 3 in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Ripke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et al., 2014 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-8389" y="6501468"/>
            <a:ext cx="2655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Table 11</a:t>
            </a:r>
          </a:p>
        </p:txBody>
      </p:sp>
    </p:spTree>
    <p:extLst>
      <p:ext uri="{BB962C8B-B14F-4D97-AF65-F5344CB8AC3E}">
        <p14:creationId xmlns:p14="http://schemas.microsoft.com/office/powerpoint/2010/main" val="36856528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36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The Broad Institut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niel Fass</dc:creator>
  <cp:lastModifiedBy>Fass, Daniel Mark</cp:lastModifiedBy>
  <cp:revision>11</cp:revision>
  <dcterms:created xsi:type="dcterms:W3CDTF">2018-03-20T00:57:21Z</dcterms:created>
  <dcterms:modified xsi:type="dcterms:W3CDTF">2018-03-22T16:20:23Z</dcterms:modified>
</cp:coreProperties>
</file>